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7" r:id="rId2"/>
    <p:sldId id="257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9144000" cy="6858000" type="screen4x3"/>
  <p:notesSz cx="6858000" cy="9144000"/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中度样式 3 - 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3" d="100"/>
          <a:sy n="83" d="100"/>
        </p:scale>
        <p:origin x="1450" y="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 showFormatting="0"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fontAlgn="base"/>
            <a:r>
              <a:rPr lang="zh-CN" altLang="en-US" strike="noStrike" noProof="1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vert="horz" wrap="square" lIns="91440" tIns="45720" rIns="91440" bIns="45720" numCol="1" rtlCol="0" anchor="t" anchorCtr="0" compatLnSpc="1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defRPr/>
            </a:pPr>
            <a:endParaRPr kumimoji="0" lang="zh-CN" altLang="en-US" sz="3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lstStyle/>
          <a:p>
            <a:pPr lvl="0"/>
            <a:r>
              <a:rPr lang="zh-CN" altLang="en-US" dirty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 indent="-285750"/>
            <a:r>
              <a:rPr lang="zh-CN" altLang="en-US" dirty="0"/>
              <a:t>第二级</a:t>
            </a:r>
          </a:p>
          <a:p>
            <a:pPr lvl="2" indent="-228600"/>
            <a:r>
              <a:rPr lang="zh-CN" altLang="en-US" dirty="0"/>
              <a:t>第三级</a:t>
            </a:r>
          </a:p>
          <a:p>
            <a:pPr lvl="3" indent="-228600"/>
            <a:r>
              <a:rPr lang="zh-CN" altLang="en-US" dirty="0"/>
              <a:t>第四级</a:t>
            </a:r>
          </a:p>
          <a:p>
            <a:pPr lvl="4" indent="-228600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E3B9CF1-3417-42DE-904E-AFF091A605C5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2024/1/3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/>
          <a:lstStyle>
            <a:lvl1pPr algn="r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 lvl="0" eaLnBrk="1" fontAlgn="base" hangingPunct="1"/>
            <a:fld id="{9A0DB2DC-4C9A-4742-B13C-FB6460FD3503}" type="slidenum">
              <a:rPr lang="zh-CN" altLang="en-US" strike="noStrike" noProof="1" dirty="0">
                <a:latin typeface="Calibri" panose="020F050202020403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571500" y="714375"/>
          <a:ext cx="8072436" cy="5715003"/>
        </p:xfrm>
        <a:graphic>
          <a:graphicData uri="http://schemas.openxmlformats.org/drawingml/2006/table">
            <a:tbl>
              <a:tblPr>
                <a:tableStyleId>{2A488322-F2BA-4B5B-9748-0D474271808F}</a:tableStyleId>
              </a:tblPr>
              <a:tblGrid>
                <a:gridCol w="134540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4540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4540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4540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4540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4540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NAC</a:t>
                      </a:r>
                      <a:r>
                        <a:rPr lang="zh-CN" altLang="en-US" sz="1600" u="none" strike="noStrike" dirty="0"/>
                        <a:t>组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600" u="none" strike="noStrike"/>
                        <a:t>新编号</a:t>
                      </a:r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PFC</a:t>
                      </a:r>
                      <a:r>
                        <a:rPr lang="zh-CN" altLang="en-US" sz="1600" u="none" strike="noStrike"/>
                        <a:t>组</a:t>
                      </a:r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600" u="none" strike="noStrike" dirty="0"/>
                        <a:t>新编号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CPU</a:t>
                      </a:r>
                      <a:r>
                        <a:rPr lang="zh-CN" altLang="en-US" sz="1600" u="none" strike="noStrike" dirty="0"/>
                        <a:t>组</a:t>
                      </a:r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600" u="none" strike="noStrike"/>
                        <a:t>新编号</a:t>
                      </a:r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NF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F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SF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F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F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F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SF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F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F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F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SF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F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F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F7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F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10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F10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10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F10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SF10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F10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1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F1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SF1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F1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SF1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F1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B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B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H 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B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15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B15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15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B15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H 15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B15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1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B1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1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B17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H 17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B17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1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B1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1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B1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H 1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B1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2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B2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2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B28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H 28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B2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2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B2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H 2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B2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H 2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B29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1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D1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1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D1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L 1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D1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16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D16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16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D16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L 16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D16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1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D1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1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D18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L 18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D18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2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D2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2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D2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L 2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D2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2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ND2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2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D2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L 2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CD2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721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2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ND2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/>
                        <a:t>MF-L 24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PD2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MF-L 2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/>
                        <a:t>CD2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2205" name="TextBox 2"/>
          <p:cNvSpPr txBox="1"/>
          <p:nvPr/>
        </p:nvSpPr>
        <p:spPr>
          <a:xfrm>
            <a:off x="3643313" y="214313"/>
            <a:ext cx="1928812" cy="36988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buSzTx/>
            </a:pPr>
            <a:r>
              <a:rPr lang="zh-CN" altLang="en-US" dirty="0">
                <a:latin typeface="宋体" panose="02010600030101010101" pitchFamily="2" charset="-122"/>
                <a:ea typeface="宋体" panose="02010600030101010101" pitchFamily="2" charset="-122"/>
              </a:rPr>
              <a:t>样本新编号对照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89" name="TextBox 1"/>
          <p:cNvSpPr txBox="1"/>
          <p:nvPr/>
        </p:nvSpPr>
        <p:spPr>
          <a:xfrm>
            <a:off x="2357438" y="5032375"/>
            <a:ext cx="4286250" cy="175418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(Epitomics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2960-1)   1:5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(Abcam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ab85367)  1:4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(Santa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sc-9114)  1:5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(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天德悦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鼠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TDY042)    1:20000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2290" name="矩形 2"/>
          <p:cNvSpPr/>
          <p:nvPr/>
        </p:nvSpPr>
        <p:spPr>
          <a:xfrm>
            <a:off x="1143000" y="1030288"/>
            <a:ext cx="706438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2291" name="矩形 3"/>
          <p:cNvSpPr/>
          <p:nvPr/>
        </p:nvSpPr>
        <p:spPr>
          <a:xfrm>
            <a:off x="1071563" y="1590675"/>
            <a:ext cx="868362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2292" name="矩形 5"/>
          <p:cNvSpPr/>
          <p:nvPr/>
        </p:nvSpPr>
        <p:spPr>
          <a:xfrm>
            <a:off x="1216025" y="2500313"/>
            <a:ext cx="569913" cy="36988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2293" name="矩形 6"/>
          <p:cNvSpPr/>
          <p:nvPr/>
        </p:nvSpPr>
        <p:spPr>
          <a:xfrm>
            <a:off x="1071563" y="3143250"/>
            <a:ext cx="868362" cy="369888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2294" name="矩形 7"/>
          <p:cNvSpPr/>
          <p:nvPr/>
        </p:nvSpPr>
        <p:spPr>
          <a:xfrm>
            <a:off x="1194301" y="3975100"/>
            <a:ext cx="569387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2295" name="矩形 8"/>
          <p:cNvSpPr/>
          <p:nvPr/>
        </p:nvSpPr>
        <p:spPr>
          <a:xfrm>
            <a:off x="1000125" y="4587875"/>
            <a:ext cx="868363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2296" name="TextBox 10"/>
          <p:cNvSpPr txBox="1"/>
          <p:nvPr/>
        </p:nvSpPr>
        <p:spPr>
          <a:xfrm>
            <a:off x="2500313" y="571500"/>
            <a:ext cx="4357687" cy="33813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zh-CN" altLang="en-US" sz="1600" dirty="0">
                <a:latin typeface="Calibri" panose="020F0502020204030204" pitchFamily="34" charset="0"/>
                <a:ea typeface="宋体" panose="02010600030101010101" pitchFamily="2" charset="-122"/>
              </a:rPr>
              <a:t>公共             </a:t>
            </a:r>
            <a:r>
              <a:rPr lang="en-US" altLang="zh-CN" sz="1600" dirty="0">
                <a:latin typeface="Calibri" panose="020F0502020204030204" pitchFamily="34" charset="0"/>
                <a:ea typeface="宋体" panose="02010600030101010101" pitchFamily="2" charset="-122"/>
              </a:rPr>
              <a:t>CF10   CB28  CD23  CF11  CB29  CD24</a:t>
            </a:r>
            <a:endParaRPr lang="zh-CN" altLang="en-US" sz="16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12297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8875" y="1000125"/>
            <a:ext cx="4319588" cy="4413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298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8875" y="2459038"/>
            <a:ext cx="4319588" cy="5222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299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8875" y="3929063"/>
            <a:ext cx="4319588" cy="4746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300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28875" y="1587500"/>
            <a:ext cx="4319588" cy="4492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301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28875" y="3117850"/>
            <a:ext cx="4319588" cy="4889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302" name="Picture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28875" y="4527550"/>
            <a:ext cx="4319588" cy="473075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3" name="TextBox 1"/>
          <p:cNvSpPr txBox="1"/>
          <p:nvPr/>
        </p:nvSpPr>
        <p:spPr>
          <a:xfrm>
            <a:off x="2428875" y="4929188"/>
            <a:ext cx="4286250" cy="175418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(Epitomics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2960-1)   1:5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(Abcam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ab85367)  1:4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(Santa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sc-9114)  1:5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(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天德悦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鼠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TDY042)    1:20000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3074" name="矩形 2"/>
          <p:cNvSpPr/>
          <p:nvPr/>
        </p:nvSpPr>
        <p:spPr>
          <a:xfrm>
            <a:off x="1143000" y="985838"/>
            <a:ext cx="706438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3075" name="矩形 3"/>
          <p:cNvSpPr/>
          <p:nvPr/>
        </p:nvSpPr>
        <p:spPr>
          <a:xfrm>
            <a:off x="1071563" y="1546225"/>
            <a:ext cx="868362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3076" name="TextBox 4"/>
          <p:cNvSpPr txBox="1"/>
          <p:nvPr/>
        </p:nvSpPr>
        <p:spPr>
          <a:xfrm>
            <a:off x="2571750" y="557213"/>
            <a:ext cx="4429125" cy="339725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zh-CN" altLang="en-US" sz="1600" dirty="0">
                <a:latin typeface="Calibri" panose="020F0502020204030204" pitchFamily="34" charset="0"/>
                <a:ea typeface="宋体" panose="02010600030101010101" pitchFamily="2" charset="-122"/>
              </a:rPr>
              <a:t>公共             </a:t>
            </a:r>
            <a:r>
              <a:rPr lang="en-US" altLang="zh-CN" sz="1600" dirty="0">
                <a:latin typeface="Calibri" panose="020F0502020204030204" pitchFamily="34" charset="0"/>
                <a:ea typeface="宋体" panose="02010600030101010101" pitchFamily="2" charset="-122"/>
              </a:rPr>
              <a:t>NF1    NB9    ND14  NF2   NB15  ND16</a:t>
            </a:r>
            <a:endParaRPr lang="zh-CN" altLang="en-US" sz="16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3077" name="矩形 5"/>
          <p:cNvSpPr/>
          <p:nvPr/>
        </p:nvSpPr>
        <p:spPr>
          <a:xfrm>
            <a:off x="1216025" y="2384425"/>
            <a:ext cx="569913" cy="368300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3078" name="矩形 6"/>
          <p:cNvSpPr/>
          <p:nvPr/>
        </p:nvSpPr>
        <p:spPr>
          <a:xfrm>
            <a:off x="1071563" y="3027363"/>
            <a:ext cx="868362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3079" name="矩形 7"/>
          <p:cNvSpPr/>
          <p:nvPr/>
        </p:nvSpPr>
        <p:spPr>
          <a:xfrm>
            <a:off x="1194301" y="3827463"/>
            <a:ext cx="569387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3080" name="矩形 8"/>
          <p:cNvSpPr/>
          <p:nvPr/>
        </p:nvSpPr>
        <p:spPr>
          <a:xfrm>
            <a:off x="1000125" y="4387850"/>
            <a:ext cx="868363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3081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6975" y="2301875"/>
            <a:ext cx="4319588" cy="5111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82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6975" y="3756025"/>
            <a:ext cx="4319588" cy="5000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83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66975" y="985838"/>
            <a:ext cx="4319588" cy="4683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84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66975" y="2984500"/>
            <a:ext cx="4319588" cy="4714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85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66975" y="1557338"/>
            <a:ext cx="4319588" cy="4429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86" name="Picture 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66975" y="4398963"/>
            <a:ext cx="4319588" cy="458787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TextBox 4"/>
          <p:cNvSpPr txBox="1"/>
          <p:nvPr/>
        </p:nvSpPr>
        <p:spPr>
          <a:xfrm>
            <a:off x="2500313" y="785813"/>
            <a:ext cx="4429125" cy="33813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zh-CN" altLang="en-US" sz="1600" dirty="0">
                <a:latin typeface="Calibri" panose="020F0502020204030204" pitchFamily="34" charset="0"/>
                <a:ea typeface="宋体" panose="02010600030101010101" pitchFamily="2" charset="-122"/>
              </a:rPr>
              <a:t>公共               </a:t>
            </a:r>
            <a:r>
              <a:rPr lang="en-US" altLang="zh-CN" sz="1600" dirty="0">
                <a:latin typeface="Calibri" panose="020F0502020204030204" pitchFamily="34" charset="0"/>
                <a:ea typeface="宋体" panose="02010600030101010101" pitchFamily="2" charset="-122"/>
              </a:rPr>
              <a:t>NF3  NB17  ND18  NF7    NB19 ND22 </a:t>
            </a:r>
            <a:endParaRPr lang="zh-CN" altLang="en-US" sz="16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4098" name="TextBox 5"/>
          <p:cNvSpPr txBox="1"/>
          <p:nvPr/>
        </p:nvSpPr>
        <p:spPr>
          <a:xfrm>
            <a:off x="2428875" y="5032375"/>
            <a:ext cx="4286250" cy="175418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(Epitomics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2960-1)   1:5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(Abcam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ab85367)  1:4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(Santa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sc-9114)  1:5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(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天德悦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鼠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TDY042)    1:20000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4099" name="矩形 6"/>
          <p:cNvSpPr/>
          <p:nvPr/>
        </p:nvSpPr>
        <p:spPr>
          <a:xfrm>
            <a:off x="1000125" y="1219200"/>
            <a:ext cx="706438" cy="369888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4100" name="矩形 7"/>
          <p:cNvSpPr/>
          <p:nvPr/>
        </p:nvSpPr>
        <p:spPr>
          <a:xfrm>
            <a:off x="928688" y="1785938"/>
            <a:ext cx="868362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4101" name="矩形 8"/>
          <p:cNvSpPr/>
          <p:nvPr/>
        </p:nvSpPr>
        <p:spPr>
          <a:xfrm>
            <a:off x="1073150" y="2570163"/>
            <a:ext cx="569913" cy="36988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4102" name="矩形 9"/>
          <p:cNvSpPr/>
          <p:nvPr/>
        </p:nvSpPr>
        <p:spPr>
          <a:xfrm>
            <a:off x="928688" y="3233738"/>
            <a:ext cx="868362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4104" name="矩形 11"/>
          <p:cNvSpPr/>
          <p:nvPr/>
        </p:nvSpPr>
        <p:spPr>
          <a:xfrm>
            <a:off x="857250" y="4551363"/>
            <a:ext cx="868363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4105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8875" y="3986213"/>
            <a:ext cx="4319588" cy="4413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6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8875" y="2516188"/>
            <a:ext cx="4319588" cy="4810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7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8875" y="1214438"/>
            <a:ext cx="4319588" cy="4000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8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28875" y="4522788"/>
            <a:ext cx="4319588" cy="4778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28875" y="3160713"/>
            <a:ext cx="4319588" cy="4984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28875" y="1752600"/>
            <a:ext cx="4319588" cy="461963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矩形 7">
            <a:extLst>
              <a:ext uri="{FF2B5EF4-FFF2-40B4-BE49-F238E27FC236}">
                <a16:creationId xmlns:a16="http://schemas.microsoft.com/office/drawing/2014/main" id="{62AC89DB-FA01-DE60-9EA5-4C63A7B8E97B}"/>
              </a:ext>
            </a:extLst>
          </p:cNvPr>
          <p:cNvSpPr/>
          <p:nvPr/>
        </p:nvSpPr>
        <p:spPr>
          <a:xfrm>
            <a:off x="1068650" y="4058206"/>
            <a:ext cx="569387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1" name="TextBox 1"/>
          <p:cNvSpPr txBox="1"/>
          <p:nvPr/>
        </p:nvSpPr>
        <p:spPr>
          <a:xfrm>
            <a:off x="2500313" y="4929188"/>
            <a:ext cx="4286250" cy="175418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(Epitomics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2960-1)   1:5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(Abcam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ab85367)  1:4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(Santa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sc-9114)  1:5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(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天德悦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鼠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TDY042)    1:20000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5122" name="矩形 2"/>
          <p:cNvSpPr/>
          <p:nvPr/>
        </p:nvSpPr>
        <p:spPr>
          <a:xfrm>
            <a:off x="1101725" y="1143000"/>
            <a:ext cx="708025" cy="369888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5123" name="矩形 3"/>
          <p:cNvSpPr/>
          <p:nvPr/>
        </p:nvSpPr>
        <p:spPr>
          <a:xfrm>
            <a:off x="1000125" y="1630363"/>
            <a:ext cx="868363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5124" name="矩形 4"/>
          <p:cNvSpPr/>
          <p:nvPr/>
        </p:nvSpPr>
        <p:spPr>
          <a:xfrm>
            <a:off x="1144588" y="2470150"/>
            <a:ext cx="569912" cy="368300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5125" name="矩形 5"/>
          <p:cNvSpPr/>
          <p:nvPr/>
        </p:nvSpPr>
        <p:spPr>
          <a:xfrm>
            <a:off x="1000125" y="3028950"/>
            <a:ext cx="868363" cy="369888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5126" name="矩形 6"/>
          <p:cNvSpPr/>
          <p:nvPr/>
        </p:nvSpPr>
        <p:spPr>
          <a:xfrm>
            <a:off x="1116600" y="3880140"/>
            <a:ext cx="569387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5127" name="矩形 7"/>
          <p:cNvSpPr/>
          <p:nvPr/>
        </p:nvSpPr>
        <p:spPr>
          <a:xfrm>
            <a:off x="928688" y="4387850"/>
            <a:ext cx="868362" cy="369888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5128" name="TextBox 8"/>
          <p:cNvSpPr txBox="1"/>
          <p:nvPr/>
        </p:nvSpPr>
        <p:spPr>
          <a:xfrm>
            <a:off x="2500313" y="714375"/>
            <a:ext cx="4357687" cy="33813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zh-CN" altLang="en-US" sz="1600" dirty="0">
                <a:latin typeface="Calibri" panose="020F0502020204030204" pitchFamily="34" charset="0"/>
                <a:ea typeface="宋体" panose="02010600030101010101" pitchFamily="2" charset="-122"/>
              </a:rPr>
              <a:t>公共              </a:t>
            </a:r>
            <a:r>
              <a:rPr lang="en-US" altLang="zh-CN" sz="1600" dirty="0">
                <a:latin typeface="Calibri" panose="020F0502020204030204" pitchFamily="34" charset="0"/>
                <a:ea typeface="宋体" panose="02010600030101010101" pitchFamily="2" charset="-122"/>
              </a:rPr>
              <a:t>NF10  NB28 ND23 NF11  NB29  ND24</a:t>
            </a:r>
            <a:endParaRPr lang="zh-CN" altLang="en-US" sz="16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5129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0313" y="3857625"/>
            <a:ext cx="4319587" cy="3984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30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0313" y="2428875"/>
            <a:ext cx="4319587" cy="4587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31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00313" y="1143000"/>
            <a:ext cx="4319587" cy="4032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32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00313" y="3000375"/>
            <a:ext cx="4319587" cy="4492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33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00313" y="4368800"/>
            <a:ext cx="4319587" cy="4175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34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00313" y="1643063"/>
            <a:ext cx="4319587" cy="425450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5" name="TextBox 1"/>
          <p:cNvSpPr txBox="1"/>
          <p:nvPr/>
        </p:nvSpPr>
        <p:spPr>
          <a:xfrm>
            <a:off x="2428875" y="4889500"/>
            <a:ext cx="4286250" cy="175418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(Epitomics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2960-1)   1:5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(Abcam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ab85367)  1:4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(Santa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sc-9114)  1:5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(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天德悦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鼠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TDY042)    1:20000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6146" name="矩形 2"/>
          <p:cNvSpPr/>
          <p:nvPr/>
        </p:nvSpPr>
        <p:spPr>
          <a:xfrm>
            <a:off x="1000125" y="1100138"/>
            <a:ext cx="706438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6147" name="矩形 3"/>
          <p:cNvSpPr/>
          <p:nvPr/>
        </p:nvSpPr>
        <p:spPr>
          <a:xfrm>
            <a:off x="928688" y="1660525"/>
            <a:ext cx="868362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6148" name="TextBox 4"/>
          <p:cNvSpPr txBox="1"/>
          <p:nvPr/>
        </p:nvSpPr>
        <p:spPr>
          <a:xfrm>
            <a:off x="2571750" y="642938"/>
            <a:ext cx="4429125" cy="33813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zh-CN" altLang="en-US" sz="1600" dirty="0">
                <a:latin typeface="Calibri" panose="020F0502020204030204" pitchFamily="34" charset="0"/>
                <a:ea typeface="宋体" panose="02010600030101010101" pitchFamily="2" charset="-122"/>
              </a:rPr>
              <a:t>公共               </a:t>
            </a:r>
            <a:r>
              <a:rPr lang="en-US" altLang="zh-CN" sz="1600" dirty="0">
                <a:latin typeface="Calibri" panose="020F0502020204030204" pitchFamily="34" charset="0"/>
                <a:ea typeface="宋体" panose="02010600030101010101" pitchFamily="2" charset="-122"/>
              </a:rPr>
              <a:t>PF1    PB9     PD14  PF2   PB15   PD16</a:t>
            </a:r>
            <a:endParaRPr lang="zh-CN" altLang="en-US" sz="16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6149" name="矩形 5"/>
          <p:cNvSpPr/>
          <p:nvPr/>
        </p:nvSpPr>
        <p:spPr>
          <a:xfrm>
            <a:off x="1073150" y="2428875"/>
            <a:ext cx="569913" cy="36988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6150" name="矩形 6"/>
          <p:cNvSpPr/>
          <p:nvPr/>
        </p:nvSpPr>
        <p:spPr>
          <a:xfrm>
            <a:off x="928688" y="3071813"/>
            <a:ext cx="868362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6151" name="矩形 7"/>
          <p:cNvSpPr/>
          <p:nvPr/>
        </p:nvSpPr>
        <p:spPr>
          <a:xfrm>
            <a:off x="1047571" y="3841751"/>
            <a:ext cx="569387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6152" name="矩形 8"/>
          <p:cNvSpPr/>
          <p:nvPr/>
        </p:nvSpPr>
        <p:spPr>
          <a:xfrm>
            <a:off x="857250" y="4402138"/>
            <a:ext cx="868363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6153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0313" y="3786188"/>
            <a:ext cx="4319587" cy="4206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4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0313" y="3036888"/>
            <a:ext cx="4319587" cy="4635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5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00313" y="1028700"/>
            <a:ext cx="4319587" cy="4667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6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86025" y="2428875"/>
            <a:ext cx="4319588" cy="4460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7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00313" y="4362450"/>
            <a:ext cx="4319587" cy="4794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8" name="Picture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00313" y="1600200"/>
            <a:ext cx="4319587" cy="471488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TextBox 1"/>
          <p:cNvSpPr txBox="1"/>
          <p:nvPr/>
        </p:nvSpPr>
        <p:spPr>
          <a:xfrm>
            <a:off x="2428875" y="4902200"/>
            <a:ext cx="4286250" cy="175418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(Epitomics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2960-1)   1:5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(Abcam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ab85367)  1:4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(Santa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sc-9114)  1:5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(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天德悦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鼠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TDY042)    1:20000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7170" name="矩形 2"/>
          <p:cNvSpPr/>
          <p:nvPr/>
        </p:nvSpPr>
        <p:spPr>
          <a:xfrm>
            <a:off x="1143000" y="1168400"/>
            <a:ext cx="706438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7171" name="矩形 3"/>
          <p:cNvSpPr/>
          <p:nvPr/>
        </p:nvSpPr>
        <p:spPr>
          <a:xfrm>
            <a:off x="1071563" y="1746250"/>
            <a:ext cx="868362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7172" name="矩形 5"/>
          <p:cNvSpPr/>
          <p:nvPr/>
        </p:nvSpPr>
        <p:spPr>
          <a:xfrm>
            <a:off x="1216025" y="2492375"/>
            <a:ext cx="569913" cy="368300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7173" name="矩形 6"/>
          <p:cNvSpPr/>
          <p:nvPr/>
        </p:nvSpPr>
        <p:spPr>
          <a:xfrm>
            <a:off x="1071563" y="3041650"/>
            <a:ext cx="868362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7174" name="矩形 7"/>
          <p:cNvSpPr/>
          <p:nvPr/>
        </p:nvSpPr>
        <p:spPr>
          <a:xfrm>
            <a:off x="1143000" y="3857625"/>
            <a:ext cx="712788" cy="369888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7175" name="矩形 8"/>
          <p:cNvSpPr/>
          <p:nvPr/>
        </p:nvSpPr>
        <p:spPr>
          <a:xfrm>
            <a:off x="1058863" y="4357688"/>
            <a:ext cx="869950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7176" name="TextBox 10"/>
          <p:cNvSpPr txBox="1"/>
          <p:nvPr/>
        </p:nvSpPr>
        <p:spPr>
          <a:xfrm>
            <a:off x="2571750" y="704850"/>
            <a:ext cx="4429125" cy="33813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zh-CN" altLang="en-US" sz="1600" dirty="0">
                <a:latin typeface="Calibri" panose="020F0502020204030204" pitchFamily="34" charset="0"/>
                <a:ea typeface="宋体" panose="02010600030101010101" pitchFamily="2" charset="-122"/>
              </a:rPr>
              <a:t>公共              </a:t>
            </a:r>
            <a:r>
              <a:rPr lang="en-US" altLang="zh-CN" sz="1600" dirty="0">
                <a:latin typeface="Calibri" panose="020F0502020204030204" pitchFamily="34" charset="0"/>
                <a:ea typeface="宋体" panose="02010600030101010101" pitchFamily="2" charset="-122"/>
              </a:rPr>
              <a:t>PF3   PB17   PD18   PF7   PB19  PD22 </a:t>
            </a:r>
            <a:endParaRPr lang="zh-CN" altLang="en-US" sz="16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7177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0313" y="3786188"/>
            <a:ext cx="4319587" cy="4349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78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0313" y="4360863"/>
            <a:ext cx="4319587" cy="5095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79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00313" y="1704975"/>
            <a:ext cx="4319587" cy="4381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80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00313" y="1114425"/>
            <a:ext cx="4319587" cy="4667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81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00313" y="2435225"/>
            <a:ext cx="4319587" cy="4937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82" name="Picture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00313" y="3041650"/>
            <a:ext cx="4319587" cy="442913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3" name="TextBox 1"/>
          <p:cNvSpPr txBox="1"/>
          <p:nvPr/>
        </p:nvSpPr>
        <p:spPr>
          <a:xfrm>
            <a:off x="2428875" y="4960938"/>
            <a:ext cx="4286250" cy="175418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(Epitomics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2960-1)   1:5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(Abcam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ab85367)  1:4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(Santa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sc-9114)  1:5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(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天德悦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鼠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TDY042)    1:20000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8194" name="矩形 2"/>
          <p:cNvSpPr/>
          <p:nvPr/>
        </p:nvSpPr>
        <p:spPr>
          <a:xfrm>
            <a:off x="1143000" y="1138238"/>
            <a:ext cx="706438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8195" name="矩形 3"/>
          <p:cNvSpPr/>
          <p:nvPr/>
        </p:nvSpPr>
        <p:spPr>
          <a:xfrm>
            <a:off x="1071563" y="1773238"/>
            <a:ext cx="868362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8196" name="矩形 5"/>
          <p:cNvSpPr/>
          <p:nvPr/>
        </p:nvSpPr>
        <p:spPr>
          <a:xfrm>
            <a:off x="1216025" y="2500313"/>
            <a:ext cx="569913" cy="36988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8197" name="矩形 6"/>
          <p:cNvSpPr/>
          <p:nvPr/>
        </p:nvSpPr>
        <p:spPr>
          <a:xfrm>
            <a:off x="1071563" y="3143250"/>
            <a:ext cx="868362" cy="369888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8198" name="矩形 7"/>
          <p:cNvSpPr/>
          <p:nvPr/>
        </p:nvSpPr>
        <p:spPr>
          <a:xfrm>
            <a:off x="1149612" y="3916640"/>
            <a:ext cx="569387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8199" name="矩形 8"/>
          <p:cNvSpPr/>
          <p:nvPr/>
        </p:nvSpPr>
        <p:spPr>
          <a:xfrm>
            <a:off x="1000125" y="4487863"/>
            <a:ext cx="868363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8200" name="TextBox 10"/>
          <p:cNvSpPr txBox="1"/>
          <p:nvPr/>
        </p:nvSpPr>
        <p:spPr>
          <a:xfrm>
            <a:off x="2571750" y="714375"/>
            <a:ext cx="4357688" cy="33813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zh-CN" altLang="en-US" sz="1600" dirty="0">
                <a:latin typeface="Calibri" panose="020F0502020204030204" pitchFamily="34" charset="0"/>
                <a:ea typeface="宋体" panose="02010600030101010101" pitchFamily="2" charset="-122"/>
              </a:rPr>
              <a:t>公共             </a:t>
            </a:r>
            <a:r>
              <a:rPr lang="en-US" altLang="zh-CN" sz="1600" dirty="0">
                <a:latin typeface="Calibri" panose="020F0502020204030204" pitchFamily="34" charset="0"/>
                <a:ea typeface="宋体" panose="02010600030101010101" pitchFamily="2" charset="-122"/>
              </a:rPr>
              <a:t>PF10  PB28   PD23  PF11  PB29  PD24</a:t>
            </a:r>
            <a:endParaRPr lang="zh-CN" altLang="en-US" sz="16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8201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0313" y="3873500"/>
            <a:ext cx="4319587" cy="4556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2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0313" y="1143000"/>
            <a:ext cx="4319587" cy="4365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3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00313" y="2479675"/>
            <a:ext cx="4319587" cy="4556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4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00313" y="1673225"/>
            <a:ext cx="4319587" cy="4619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5" name="Picture 6"/>
          <p:cNvPicPr>
            <a:picLocks noChangeAspect="1"/>
          </p:cNvPicPr>
          <p:nvPr/>
        </p:nvPicPr>
        <p:blipFill>
          <a:blip r:embed="rId6">
            <a:lum bright="7999" contrast="8000"/>
          </a:blip>
          <a:stretch>
            <a:fillRect/>
          </a:stretch>
        </p:blipFill>
        <p:spPr>
          <a:xfrm>
            <a:off x="2500313" y="3143250"/>
            <a:ext cx="4319587" cy="4492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6" name="Picture 7"/>
          <p:cNvPicPr>
            <a:picLocks noChangeAspect="1"/>
          </p:cNvPicPr>
          <p:nvPr/>
        </p:nvPicPr>
        <p:blipFill>
          <a:blip r:embed="rId7">
            <a:lum bright="7999" contrast="8000"/>
          </a:blip>
          <a:stretch>
            <a:fillRect/>
          </a:stretch>
        </p:blipFill>
        <p:spPr>
          <a:xfrm>
            <a:off x="2500313" y="4445000"/>
            <a:ext cx="4319587" cy="434975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1" name="TextBox 1"/>
          <p:cNvSpPr txBox="1"/>
          <p:nvPr/>
        </p:nvSpPr>
        <p:spPr>
          <a:xfrm>
            <a:off x="2428875" y="4932363"/>
            <a:ext cx="4286250" cy="175418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(Epitomics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2960-1)   1:5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(Abcam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ab85367)  1:4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(Santa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sc-9114)  1:5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(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天德悦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鼠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TDY042)    1:20000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0242" name="矩形 2"/>
          <p:cNvSpPr/>
          <p:nvPr/>
        </p:nvSpPr>
        <p:spPr>
          <a:xfrm>
            <a:off x="1252538" y="1071563"/>
            <a:ext cx="706437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0243" name="矩形 3"/>
          <p:cNvSpPr/>
          <p:nvPr/>
        </p:nvSpPr>
        <p:spPr>
          <a:xfrm>
            <a:off x="1181100" y="1689100"/>
            <a:ext cx="868363" cy="369888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0244" name="TextBox 4"/>
          <p:cNvSpPr txBox="1"/>
          <p:nvPr/>
        </p:nvSpPr>
        <p:spPr>
          <a:xfrm>
            <a:off x="2500313" y="642938"/>
            <a:ext cx="4429125" cy="33813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zh-CN" altLang="en-US" sz="1600" dirty="0">
                <a:latin typeface="Calibri" panose="020F0502020204030204" pitchFamily="34" charset="0"/>
                <a:ea typeface="宋体" panose="02010600030101010101" pitchFamily="2" charset="-122"/>
              </a:rPr>
              <a:t>公共               </a:t>
            </a:r>
            <a:r>
              <a:rPr lang="en-US" altLang="zh-CN" sz="1600" dirty="0">
                <a:latin typeface="Calibri" panose="020F0502020204030204" pitchFamily="34" charset="0"/>
                <a:ea typeface="宋体" panose="02010600030101010101" pitchFamily="2" charset="-122"/>
              </a:rPr>
              <a:t>CF1    CB9    CD14   CF2    CB15  CD16</a:t>
            </a:r>
            <a:endParaRPr lang="zh-CN" altLang="en-US" sz="16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0245" name="矩形 5"/>
          <p:cNvSpPr/>
          <p:nvPr/>
        </p:nvSpPr>
        <p:spPr>
          <a:xfrm>
            <a:off x="1325563" y="2428875"/>
            <a:ext cx="569912" cy="36988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0246" name="矩形 6"/>
          <p:cNvSpPr/>
          <p:nvPr/>
        </p:nvSpPr>
        <p:spPr>
          <a:xfrm>
            <a:off x="1181100" y="3071813"/>
            <a:ext cx="868363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0247" name="矩形 7"/>
          <p:cNvSpPr/>
          <p:nvPr/>
        </p:nvSpPr>
        <p:spPr>
          <a:xfrm>
            <a:off x="1293809" y="3843337"/>
            <a:ext cx="569387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0248" name="矩形 8"/>
          <p:cNvSpPr/>
          <p:nvPr/>
        </p:nvSpPr>
        <p:spPr>
          <a:xfrm>
            <a:off x="1109663" y="4460875"/>
            <a:ext cx="868362" cy="368300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10249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6975" y="1050925"/>
            <a:ext cx="4319588" cy="4492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50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6975" y="2357438"/>
            <a:ext cx="4319588" cy="482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51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66975" y="3786188"/>
            <a:ext cx="4319588" cy="5127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52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66975" y="3000375"/>
            <a:ext cx="4319588" cy="4492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53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66975" y="4437063"/>
            <a:ext cx="4319588" cy="4635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54" name="Picture 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66975" y="1630363"/>
            <a:ext cx="4319588" cy="441325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TextBox 1"/>
          <p:cNvSpPr txBox="1"/>
          <p:nvPr/>
        </p:nvSpPr>
        <p:spPr>
          <a:xfrm>
            <a:off x="2428875" y="5032375"/>
            <a:ext cx="4286250" cy="1754188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(Epitomics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2960-1)   1:5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(Abcam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ab85367)  1:40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DR(Santa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兔多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sc-9114)  1:500</a:t>
            </a:r>
          </a:p>
          <a:p>
            <a:pPr>
              <a:lnSpc>
                <a:spcPct val="150000"/>
              </a:lnSpc>
            </a:pP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(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天德悦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</a:t>
            </a:r>
            <a:r>
              <a:rPr lang="zh-CN" altLang="en-US" dirty="0">
                <a:latin typeface="Calibri" panose="020F0502020204030204" pitchFamily="34" charset="0"/>
                <a:ea typeface="宋体" panose="02010600030101010101" pitchFamily="2" charset="-122"/>
              </a:rPr>
              <a:t>鼠单抗</a:t>
            </a:r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,TDY042)    1:20000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1266" name="矩形 2"/>
          <p:cNvSpPr/>
          <p:nvPr/>
        </p:nvSpPr>
        <p:spPr>
          <a:xfrm>
            <a:off x="1143000" y="1214438"/>
            <a:ext cx="706438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BDNF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1267" name="矩形 3"/>
          <p:cNvSpPr/>
          <p:nvPr/>
        </p:nvSpPr>
        <p:spPr>
          <a:xfrm>
            <a:off x="1071563" y="1773238"/>
            <a:ext cx="868362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1268" name="矩形 5"/>
          <p:cNvSpPr/>
          <p:nvPr/>
        </p:nvSpPr>
        <p:spPr>
          <a:xfrm>
            <a:off x="1216025" y="2500313"/>
            <a:ext cx="569913" cy="36988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2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1269" name="矩形 6"/>
          <p:cNvSpPr/>
          <p:nvPr/>
        </p:nvSpPr>
        <p:spPr>
          <a:xfrm>
            <a:off x="1071563" y="3143250"/>
            <a:ext cx="868362" cy="369888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1270" name="矩形 7"/>
          <p:cNvSpPr/>
          <p:nvPr/>
        </p:nvSpPr>
        <p:spPr>
          <a:xfrm>
            <a:off x="1211525" y="3960297"/>
            <a:ext cx="569387" cy="369332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D3R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1271" name="矩形 8"/>
          <p:cNvSpPr/>
          <p:nvPr/>
        </p:nvSpPr>
        <p:spPr>
          <a:xfrm>
            <a:off x="1000125" y="4487863"/>
            <a:ext cx="868363" cy="369887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宋体" panose="02010600030101010101" pitchFamily="2" charset="-122"/>
              </a:rPr>
              <a:t>GAPDH</a:t>
            </a:r>
            <a:endParaRPr lang="zh-CN" altLang="en-US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11272" name="TextBox 10"/>
          <p:cNvSpPr txBox="1"/>
          <p:nvPr/>
        </p:nvSpPr>
        <p:spPr>
          <a:xfrm>
            <a:off x="2500313" y="661988"/>
            <a:ext cx="4429125" cy="338137"/>
          </a:xfrm>
          <a:prstGeom prst="rect">
            <a:avLst/>
          </a:prstGeom>
          <a:noFill/>
          <a:ln w="9525">
            <a:noFill/>
          </a:ln>
        </p:spPr>
        <p:txBody>
          <a:bodyPr anchor="t">
            <a:spAutoFit/>
          </a:bodyPr>
          <a:lstStyle/>
          <a:p>
            <a:r>
              <a:rPr lang="zh-CN" altLang="en-US" sz="1600" dirty="0">
                <a:latin typeface="Calibri" panose="020F0502020204030204" pitchFamily="34" charset="0"/>
                <a:ea typeface="宋体" panose="02010600030101010101" pitchFamily="2" charset="-122"/>
              </a:rPr>
              <a:t>公共               </a:t>
            </a:r>
            <a:r>
              <a:rPr lang="en-US" altLang="zh-CN" sz="1600" dirty="0">
                <a:latin typeface="Calibri" panose="020F0502020204030204" pitchFamily="34" charset="0"/>
                <a:ea typeface="宋体" panose="02010600030101010101" pitchFamily="2" charset="-122"/>
              </a:rPr>
              <a:t>CF3  CB17  CD18    CF7   CB19  CD22 </a:t>
            </a:r>
            <a:endParaRPr lang="zh-CN" altLang="en-US" sz="16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11273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1100" y="1143000"/>
            <a:ext cx="4319588" cy="4508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4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9038" y="2432050"/>
            <a:ext cx="4319587" cy="4968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5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1100" y="3932238"/>
            <a:ext cx="4319588" cy="4254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6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66975" y="3060700"/>
            <a:ext cx="4319588" cy="5111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7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51100" y="4470400"/>
            <a:ext cx="4319588" cy="4587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8" name="Pictur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55863" y="1714500"/>
            <a:ext cx="4319587" cy="420688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91</Words>
  <Application>Microsoft Office PowerPoint</Application>
  <PresentationFormat>全屏显示(4:3)</PresentationFormat>
  <Paragraphs>214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thinkpad</dc:creator>
  <cp:lastModifiedBy>云静 白</cp:lastModifiedBy>
  <cp:revision>29</cp:revision>
  <dcterms:created xsi:type="dcterms:W3CDTF">2014-06-09T08:30:00Z</dcterms:created>
  <dcterms:modified xsi:type="dcterms:W3CDTF">2024-01-03T13:47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72</vt:lpwstr>
  </property>
</Properties>
</file>